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8.jpeg" ContentType="image/jpeg"/>
  <Override PartName="/ppt/media/image13.jpeg" ContentType="image/jpeg"/>
  <Override PartName="/ppt/media/image5.jpeg" ContentType="image/jpeg"/>
  <Override PartName="/ppt/media/image9.wmf" ContentType="image/x-wmf"/>
  <Override PartName="/ppt/media/image10.jpeg" ContentType="image/jpeg"/>
  <Override PartName="/ppt/media/image6.jpeg" ContentType="image/jpeg"/>
  <Override PartName="/ppt/media/image7.wmf" ContentType="image/x-wmf"/>
  <Override PartName="/ppt/media/image11.jpeg" ContentType="image/jpeg"/>
  <Override PartName="/ppt/media/image1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0360" y="767880"/>
            <a:ext cx="5118120" cy="3838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840" rIns="9684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382209-649E-44B1-873A-89E8400F93EA}" type="slidenum">
              <a:rPr b="0" lang="en-US" sz="13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sldImg"/>
          </p:nvPr>
        </p:nvSpPr>
        <p:spPr>
          <a:xfrm>
            <a:off x="990720" y="768240"/>
            <a:ext cx="5118120" cy="3838680"/>
          </a:xfrm>
          <a:prstGeom prst="rect">
            <a:avLst/>
          </a:prstGeom>
          <a:ln w="0">
            <a:noFill/>
          </a:ln>
        </p:spPr>
      </p:sp>
      <p:sp>
        <p:nvSpPr>
          <p:cNvPr id="145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840" rIns="96840" tIns="48240" bIns="482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C83D51-7281-4E53-9899-2E0979EA6424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38320-A089-4127-B6F2-FFACEB8046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D388D-E9C4-4F4A-9FFA-BCFC355037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653E2-F844-48F6-A51E-C8A01C528A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35EE6-1D13-493A-89FC-CD2F7EA9ED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CA80A-59E2-4D4A-9765-3D97ACC754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8D0B4-58F8-4F12-BEE8-33B56912E5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DCDE5-2073-4CD4-923D-A519313B63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3E0CE-ED46-43C0-A0B8-8BC7F5D18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285E0-4781-43FE-81C8-9E331DC69B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035CD-BDAD-4416-A5B7-8863F7D0BF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E35EBC-08F1-441C-999C-B77539DB1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95A5F-2FB7-4407-B256-8B99B49DD8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F68AF9-B211-40C9-82D5-59FA69DEDC0A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jpeg"/><Relationship Id="rId3" Type="http://schemas.openxmlformats.org/officeDocument/2006/relationships/image" Target="../media/image9.wmf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jpeg"/><Relationship Id="rId4" Type="http://schemas.openxmlformats.org/officeDocument/2006/relationships/image" Target="../media/image13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457560" y="284040"/>
            <a:ext cx="393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Supplementary Table 1. List of oligomers used in the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7389720" y="6510240"/>
            <a:ext cx="161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Supplementary Tab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>
            <a:off x="181080" y="615960"/>
            <a:ext cx="8929440" cy="662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54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GATTAGATAATCAGTTCATCGAGTCCTCACGTAGATCGGTACTACTCGAGCTGAG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5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GCTAACTGCATCTGTAGGTCGCGAATCAGTTATCATTAA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57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TGATAACTGATTCGCGACCTACAGATGCAGT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0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ACTGCATCTGTAGGTCG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1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 GAGTAGTACCGATCTACGTG -3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2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TTAACTCAGCTCGAGTAGTACCGATCTACGTGAGGACTCGATGAACTGATTATC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5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GCTAACTGCATCTGTAGGTCGCGAATCAGTTCACTGCTTAA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GCAGTGAACTGATTCGCGACCTACAGATGCAGT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7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ATTAGATAATCAGTTCGAGTCCTCACGTAGATCGGTACTACTCGAGCTGAG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8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TCGAGTAGTACCGATCTACGTGAGGACTCGAACTGATTATC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69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GCTAACTGCATCTGTAGGTCGCCCAGATCTGCAGTGATGCTTAA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0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ATCACTGCAGATCTGGGCGACCTACAGATGCAGT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1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ATTAGATCAGATCTGCAGTGGCGAGTCCTCACGTAGATCGGTACTACTCGAGCTGAG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2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TCGAGTAGTACCGATCTACGTGAGGACTCGCCACTGCAGATCTGATC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3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GCTAACTGCATCTGTAGGTCGCTAGGGATAACAGGGTAAGTGCTTAA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4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ACTTACCCTGTTATCCCTAGCGACCTACAGATGCAGT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‘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5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GATTAGACAGGGATAACAGGGTAATCGAGTCCTCACGTAGATCGGTACTACTCGAGCTGAG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3'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7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 GCTCGAGTAGTACCGATCTACGTGAGGACTCGATTACCCTGTTATCCCTGTCT-3'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4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AGCTAACTGCATCTGTAGGTCGGCGGCATCATTAA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5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TGATGCCGCCGACCTACAGATGCAGT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AGCACATGGCCGCAGTCCTCACGTAGATCGGTACTACTCGAGCTGAG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7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TCGAGTAGTACCGATCTACGTGAGGACTGCGGCCATG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8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AGCTAACTGCATCTGTAGGTCGGCGGCCATCATTAA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89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TGATGGCCGCCGACCTACAGATGCAGT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0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AGCACATCGGCCGCAGTCCTCACGTAGATCGGTACTACTCGAGCTGAG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1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TCGAGTAGTACCGATCTACGTGAGGACTGCGGCCGATG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2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AGCTAACTGCATCTGTAGGTCGCTAACTATAACGGTCCTAAGGTAGCCTCATTAA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3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TGAGGCTACCTTAGGACCGTTATAGTTAGCGACCTACAGATGCAGTT-3'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4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AGCTAGAGATAACGGTCCTAAGGTAGCGAGAGTCCTCACGTAGATCGGTACTACTCGAGCTGAG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5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GCTCGAGTAGTACCGATCTACGTGAGGACTCTCGCTACCTTAGGACCGTTATCTC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'-AGCTAGAGACTATAACGGTCCTAAGGTAGCGAGAGTCCTCACGTAGATCGGTACTACTCGAGCTGAG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S97                     5'-GCTCGAGTAGTACCGATCTACGTGAGGACTCTCGCTACCTTAGGACCGTTATAGTCTCT-3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MS143                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ja-JP" sz="1100" spc="-1" strike="noStrike">
                <a:solidFill>
                  <a:srgbClr val="000000"/>
                </a:solidFill>
                <a:latin typeface="Calibri"/>
              </a:rPr>
              <a:t>’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GTTCATCGAGTCCTCACG-3</a:t>
            </a:r>
            <a:r>
              <a:rPr b="0" lang="ja-JP" sz="1100" spc="-1" strike="noStrike">
                <a:solidFill>
                  <a:srgbClr val="000000"/>
                </a:solidFill>
                <a:latin typeface="Arial"/>
              </a:rPr>
              <a:t>’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MS144                 5'-TTAACTCAGCTCGAGTAG-3'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Rectangle 3"/>
          <p:cNvSpPr/>
          <p:nvPr/>
        </p:nvSpPr>
        <p:spPr>
          <a:xfrm>
            <a:off x="7316640" y="6510240"/>
            <a:ext cx="1762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Supplementary Tab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5"/>
          <p:cNvSpPr/>
          <p:nvPr/>
        </p:nvSpPr>
        <p:spPr>
          <a:xfrm>
            <a:off x="1073880" y="638280"/>
            <a:ext cx="730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Supplementary Table 2. List of oligomers used to generate particular length of microhomology.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2500200" y="1500120"/>
          <a:ext cx="3756240" cy="3768840"/>
        </p:xfrm>
        <a:graphic>
          <a:graphicData uri="http://schemas.openxmlformats.org/drawingml/2006/table">
            <a:tbl>
              <a:tblPr/>
              <a:tblGrid>
                <a:gridCol w="1590840"/>
                <a:gridCol w="1089000"/>
                <a:gridCol w="1076400"/>
              </a:tblGrid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        </a:t>
                      </a: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Length o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microhomology (n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   </a:t>
                      </a: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Substrate 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Substrate 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84/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86/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88/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90/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56/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67/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65/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54/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69/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71/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73/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75/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92/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96/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a7bfde"/>
                    </a:solidFill>
                  </a:tcPr>
                </a:tc>
              </a:tr>
              <a:tr h="420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92/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S 94/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dfee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68"/>
          <p:cNvSpPr/>
          <p:nvPr/>
        </p:nvSpPr>
        <p:spPr>
          <a:xfrm>
            <a:off x="7026120" y="636732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5" descr=""/>
          <p:cNvPicPr/>
          <p:nvPr/>
        </p:nvPicPr>
        <p:blipFill>
          <a:blip r:embed="rId1"/>
          <a:stretch/>
        </p:blipFill>
        <p:spPr>
          <a:xfrm>
            <a:off x="1871640" y="1428840"/>
            <a:ext cx="2846520" cy="18590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" descr=""/>
          <p:cNvPicPr/>
          <p:nvPr/>
        </p:nvPicPr>
        <p:blipFill>
          <a:blip r:embed="rId2"/>
          <a:stretch/>
        </p:blipFill>
        <p:spPr>
          <a:xfrm>
            <a:off x="4848120" y="1681200"/>
            <a:ext cx="2714760" cy="1800360"/>
          </a:xfrm>
          <a:prstGeom prst="rect">
            <a:avLst/>
          </a:prstGeom>
          <a:ln w="0">
            <a:noFill/>
          </a:ln>
        </p:spPr>
      </p:pic>
      <p:sp>
        <p:nvSpPr>
          <p:cNvPr id="57" name="TextBox 119"/>
          <p:cNvSpPr/>
          <p:nvPr/>
        </p:nvSpPr>
        <p:spPr>
          <a:xfrm>
            <a:off x="1793520" y="1330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19"/>
          <p:cNvSpPr/>
          <p:nvPr/>
        </p:nvSpPr>
        <p:spPr>
          <a:xfrm>
            <a:off x="4721760" y="13302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64"/>
          <p:cNvGrpSpPr/>
          <p:nvPr/>
        </p:nvGrpSpPr>
        <p:grpSpPr>
          <a:xfrm>
            <a:off x="2360520" y="1503000"/>
            <a:ext cx="4007160" cy="1987920"/>
            <a:chOff x="2360520" y="1503000"/>
            <a:chExt cx="4007160" cy="1987920"/>
          </a:xfrm>
        </p:grpSpPr>
        <p:sp>
          <p:nvSpPr>
            <p:cNvPr id="60" name="TextBox 65"/>
            <p:cNvSpPr/>
            <p:nvPr/>
          </p:nvSpPr>
          <p:spPr>
            <a:xfrm rot="16200000">
              <a:off x="3178800" y="1756800"/>
              <a:ext cx="814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ym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Group 85"/>
            <p:cNvGrpSpPr/>
            <p:nvPr/>
          </p:nvGrpSpPr>
          <p:grpSpPr>
            <a:xfrm>
              <a:off x="2360520" y="1562760"/>
              <a:ext cx="4007160" cy="1928160"/>
              <a:chOff x="2360520" y="1562760"/>
              <a:chExt cx="4007160" cy="1928160"/>
            </a:xfrm>
          </p:grpSpPr>
          <p:sp>
            <p:nvSpPr>
              <p:cNvPr id="62" name="TextBox 69"/>
              <p:cNvSpPr/>
              <p:nvPr/>
            </p:nvSpPr>
            <p:spPr>
              <a:xfrm>
                <a:off x="284364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70"/>
              <p:cNvSpPr/>
              <p:nvPr/>
            </p:nvSpPr>
            <p:spPr>
              <a:xfrm>
                <a:off x="316944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Box 71"/>
              <p:cNvSpPr/>
              <p:nvPr/>
            </p:nvSpPr>
            <p:spPr>
              <a:xfrm>
                <a:off x="2360520" y="219420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F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Box 72"/>
              <p:cNvSpPr/>
              <p:nvPr/>
            </p:nvSpPr>
            <p:spPr>
              <a:xfrm>
                <a:off x="5312880" y="2381760"/>
                <a:ext cx="30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Box 73"/>
              <p:cNvSpPr/>
              <p:nvPr/>
            </p:nvSpPr>
            <p:spPr>
              <a:xfrm>
                <a:off x="5600520" y="2381760"/>
                <a:ext cx="33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′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2811600" y="2658960"/>
                <a:ext cx="3126240" cy="752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TextBox 75"/>
              <p:cNvSpPr/>
              <p:nvPr/>
            </p:nvSpPr>
            <p:spPr>
              <a:xfrm>
                <a:off x="343908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Box 76"/>
              <p:cNvSpPr/>
              <p:nvPr/>
            </p:nvSpPr>
            <p:spPr>
              <a:xfrm>
                <a:off x="370908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77"/>
              <p:cNvSpPr/>
              <p:nvPr/>
            </p:nvSpPr>
            <p:spPr>
              <a:xfrm>
                <a:off x="397872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Box 78"/>
              <p:cNvSpPr/>
              <p:nvPr/>
            </p:nvSpPr>
            <p:spPr>
              <a:xfrm>
                <a:off x="424836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Box 79"/>
              <p:cNvSpPr/>
              <p:nvPr/>
            </p:nvSpPr>
            <p:spPr>
              <a:xfrm>
                <a:off x="451800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Box 80"/>
              <p:cNvSpPr/>
              <p:nvPr/>
            </p:nvSpPr>
            <p:spPr>
              <a:xfrm>
                <a:off x="4759200" y="23817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Box 81"/>
              <p:cNvSpPr/>
              <p:nvPr/>
            </p:nvSpPr>
            <p:spPr>
              <a:xfrm rot="16200000">
                <a:off x="2677680" y="1827360"/>
                <a:ext cx="596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rai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Box 82"/>
              <p:cNvSpPr/>
              <p:nvPr/>
            </p:nvSpPr>
            <p:spPr>
              <a:xfrm rot="16200000">
                <a:off x="2954880" y="1845720"/>
                <a:ext cx="657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Test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Box 83"/>
              <p:cNvSpPr/>
              <p:nvPr/>
            </p:nvSpPr>
            <p:spPr>
              <a:xfrm>
                <a:off x="281988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Box 84"/>
              <p:cNvSpPr/>
              <p:nvPr/>
            </p:nvSpPr>
            <p:spPr>
              <a:xfrm>
                <a:off x="313488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Box 85"/>
              <p:cNvSpPr/>
              <p:nvPr/>
            </p:nvSpPr>
            <p:spPr>
              <a:xfrm>
                <a:off x="343584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86"/>
              <p:cNvSpPr/>
              <p:nvPr/>
            </p:nvSpPr>
            <p:spPr>
              <a:xfrm>
                <a:off x="369396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87"/>
              <p:cNvSpPr/>
              <p:nvPr/>
            </p:nvSpPr>
            <p:spPr>
              <a:xfrm>
                <a:off x="394380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88"/>
              <p:cNvSpPr/>
              <p:nvPr/>
            </p:nvSpPr>
            <p:spPr>
              <a:xfrm>
                <a:off x="420336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89"/>
              <p:cNvSpPr/>
              <p:nvPr/>
            </p:nvSpPr>
            <p:spPr>
              <a:xfrm>
                <a:off x="4491360" y="214956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Box 90"/>
              <p:cNvSpPr/>
              <p:nvPr/>
            </p:nvSpPr>
            <p:spPr>
              <a:xfrm>
                <a:off x="4728960" y="2158920"/>
                <a:ext cx="315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Box 91"/>
              <p:cNvSpPr/>
              <p:nvPr/>
            </p:nvSpPr>
            <p:spPr>
              <a:xfrm rot="16200000">
                <a:off x="3473280" y="1776960"/>
                <a:ext cx="735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Splee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Box 92"/>
              <p:cNvSpPr/>
              <p:nvPr/>
            </p:nvSpPr>
            <p:spPr>
              <a:xfrm rot="16200000">
                <a:off x="3742560" y="1812240"/>
                <a:ext cx="666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Lung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Box 93"/>
              <p:cNvSpPr/>
              <p:nvPr/>
            </p:nvSpPr>
            <p:spPr>
              <a:xfrm rot="16200000">
                <a:off x="4055760" y="1818000"/>
                <a:ext cx="616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Hear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Box 94"/>
              <p:cNvSpPr/>
              <p:nvPr/>
            </p:nvSpPr>
            <p:spPr>
              <a:xfrm rot="16200000">
                <a:off x="4358880" y="1843560"/>
                <a:ext cx="567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Live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Box 95"/>
              <p:cNvSpPr/>
              <p:nvPr/>
            </p:nvSpPr>
            <p:spPr>
              <a:xfrm rot="16200000">
                <a:off x="4514400" y="1772280"/>
                <a:ext cx="726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Kidne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TextBox 96"/>
              <p:cNvSpPr/>
              <p:nvPr/>
            </p:nvSpPr>
            <p:spPr>
              <a:xfrm>
                <a:off x="5835960" y="32446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97"/>
              <p:cNvSpPr/>
              <p:nvPr/>
            </p:nvSpPr>
            <p:spPr>
              <a:xfrm>
                <a:off x="5835960" y="303300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98"/>
              <p:cNvSpPr/>
              <p:nvPr/>
            </p:nvSpPr>
            <p:spPr>
              <a:xfrm>
                <a:off x="5836320" y="2566080"/>
                <a:ext cx="531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0 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92" name="Straight Arrow Connector 4"/>
            <p:cNvCxnSpPr/>
            <p:nvPr/>
          </p:nvCxnSpPr>
          <p:spPr>
            <a:xfrm>
              <a:off x="5060520" y="3103200"/>
              <a:ext cx="925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93" name="Right Bracket 5"/>
            <p:cNvSpPr/>
            <p:nvPr/>
          </p:nvSpPr>
          <p:spPr>
            <a:xfrm>
              <a:off x="5013360" y="2755800"/>
              <a:ext cx="44280" cy="279360"/>
            </a:xfrm>
            <a:custGeom>
              <a:avLst/>
              <a:gdLst>
                <a:gd name="textAreaLeft" fmla="*/ 0 w 44280"/>
                <a:gd name="textAreaRight" fmla="*/ 30960 w 44280"/>
                <a:gd name="textAreaTop" fmla="*/ 1800 h 279360"/>
                <a:gd name="textAreaBottom" fmla="*/ 277560 h 279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43"/>
                    <a:pt x="21600" y="286"/>
                  </a:cubicBezTo>
                  <a:lnTo>
                    <a:pt x="21600" y="21314"/>
                  </a:lnTo>
                  <a:cubicBezTo>
                    <a:pt x="21600" y="21457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Box 68"/>
          <p:cNvSpPr/>
          <p:nvPr/>
        </p:nvSpPr>
        <p:spPr>
          <a:xfrm>
            <a:off x="7004880" y="636732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Box 68"/>
          <p:cNvSpPr/>
          <p:nvPr/>
        </p:nvSpPr>
        <p:spPr>
          <a:xfrm>
            <a:off x="7004880" y="646596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Picture 3" descr=""/>
          <p:cNvPicPr/>
          <p:nvPr/>
        </p:nvPicPr>
        <p:blipFill>
          <a:blip r:embed="rId1"/>
          <a:stretch/>
        </p:blipFill>
        <p:spPr>
          <a:xfrm>
            <a:off x="228600" y="44280"/>
            <a:ext cx="8713800" cy="646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2" descr=""/>
          <p:cNvPicPr/>
          <p:nvPr/>
        </p:nvPicPr>
        <p:blipFill>
          <a:blip r:embed="rId1"/>
          <a:srcRect l="0" t="3751" r="0" b="0"/>
          <a:stretch/>
        </p:blipFill>
        <p:spPr>
          <a:xfrm>
            <a:off x="785880" y="428760"/>
            <a:ext cx="8143920" cy="6240240"/>
          </a:xfrm>
          <a:prstGeom prst="rect">
            <a:avLst/>
          </a:prstGeom>
          <a:ln w="0">
            <a:noFill/>
          </a:ln>
        </p:spPr>
      </p:pic>
      <p:sp>
        <p:nvSpPr>
          <p:cNvPr id="98" name="TextBox 2"/>
          <p:cNvSpPr/>
          <p:nvPr/>
        </p:nvSpPr>
        <p:spPr>
          <a:xfrm>
            <a:off x="7008120" y="6510240"/>
            <a:ext cx="189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3" descr=""/>
          <p:cNvPicPr/>
          <p:nvPr/>
        </p:nvPicPr>
        <p:blipFill>
          <a:blip r:embed="rId1"/>
          <a:stretch/>
        </p:blipFill>
        <p:spPr>
          <a:xfrm>
            <a:off x="1000080" y="857160"/>
            <a:ext cx="6470640" cy="3930840"/>
          </a:xfrm>
          <a:prstGeom prst="rect">
            <a:avLst/>
          </a:prstGeom>
          <a:ln w="0">
            <a:noFill/>
          </a:ln>
        </p:spPr>
      </p:pic>
      <p:sp>
        <p:nvSpPr>
          <p:cNvPr id="100" name="TextBox 2"/>
          <p:cNvSpPr/>
          <p:nvPr/>
        </p:nvSpPr>
        <p:spPr>
          <a:xfrm>
            <a:off x="6865200" y="5929200"/>
            <a:ext cx="189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4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45"/>
          <p:cNvSpPr/>
          <p:nvPr/>
        </p:nvSpPr>
        <p:spPr>
          <a:xfrm>
            <a:off x="6790680" y="642924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ight Triangle 98"/>
          <p:cNvSpPr/>
          <p:nvPr/>
        </p:nvSpPr>
        <p:spPr>
          <a:xfrm flipH="1">
            <a:off x="1981080" y="1919160"/>
            <a:ext cx="951120" cy="128880"/>
          </a:xfrm>
          <a:prstGeom prst="rtTriangl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Group 99"/>
          <p:cNvGrpSpPr/>
          <p:nvPr/>
        </p:nvGrpSpPr>
        <p:grpSpPr>
          <a:xfrm>
            <a:off x="993240" y="2036880"/>
            <a:ext cx="3551400" cy="1474560"/>
            <a:chOff x="993240" y="2036880"/>
            <a:chExt cx="3551400" cy="1474560"/>
          </a:xfrm>
        </p:grpSpPr>
        <p:sp>
          <p:nvSpPr>
            <p:cNvPr id="104" name="Text Box 63"/>
            <p:cNvSpPr/>
            <p:nvPr/>
          </p:nvSpPr>
          <p:spPr>
            <a:xfrm>
              <a:off x="1456560" y="22636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F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81"/>
            <p:cNvSpPr/>
            <p:nvPr/>
          </p:nvSpPr>
          <p:spPr>
            <a:xfrm>
              <a:off x="993240" y="2049480"/>
              <a:ext cx="1003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ortmann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197"/>
            <p:cNvSpPr/>
            <p:nvPr/>
          </p:nvSpPr>
          <p:spPr>
            <a:xfrm>
              <a:off x="2756880" y="204768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197"/>
            <p:cNvSpPr/>
            <p:nvPr/>
          </p:nvSpPr>
          <p:spPr>
            <a:xfrm>
              <a:off x="2171520" y="204768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197"/>
            <p:cNvSpPr/>
            <p:nvPr/>
          </p:nvSpPr>
          <p:spPr>
            <a:xfrm>
              <a:off x="2475000" y="204768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82"/>
            <p:cNvSpPr/>
            <p:nvPr/>
          </p:nvSpPr>
          <p:spPr>
            <a:xfrm>
              <a:off x="1860480" y="22572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106"/>
            <p:cNvSpPr/>
            <p:nvPr/>
          </p:nvSpPr>
          <p:spPr>
            <a:xfrm>
              <a:off x="1859760" y="24537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107"/>
            <p:cNvSpPr/>
            <p:nvPr/>
          </p:nvSpPr>
          <p:spPr>
            <a:xfrm>
              <a:off x="2191680" y="24537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108"/>
            <p:cNvSpPr/>
            <p:nvPr/>
          </p:nvSpPr>
          <p:spPr>
            <a:xfrm>
              <a:off x="2479680" y="24537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109"/>
            <p:cNvSpPr/>
            <p:nvPr/>
          </p:nvSpPr>
          <p:spPr>
            <a:xfrm>
              <a:off x="2761920" y="24537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110"/>
            <p:cNvSpPr/>
            <p:nvPr/>
          </p:nvSpPr>
          <p:spPr>
            <a:xfrm>
              <a:off x="3362040" y="2387160"/>
              <a:ext cx="30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5" name="Picture 5" descr=""/>
            <p:cNvPicPr/>
            <p:nvPr/>
          </p:nvPicPr>
          <p:blipFill>
            <a:blip r:embed="rId1"/>
            <a:stretch/>
          </p:blipFill>
          <p:spPr>
            <a:xfrm>
              <a:off x="1857960" y="2612160"/>
              <a:ext cx="2160360" cy="89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6" name="Text Box 197"/>
            <p:cNvSpPr/>
            <p:nvPr/>
          </p:nvSpPr>
          <p:spPr>
            <a:xfrm>
              <a:off x="2171520" y="225252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197"/>
            <p:cNvSpPr/>
            <p:nvPr/>
          </p:nvSpPr>
          <p:spPr>
            <a:xfrm>
              <a:off x="2475000" y="225252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197"/>
            <p:cNvSpPr/>
            <p:nvPr/>
          </p:nvSpPr>
          <p:spPr>
            <a:xfrm>
              <a:off x="2739960" y="225252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197"/>
            <p:cNvSpPr/>
            <p:nvPr/>
          </p:nvSpPr>
          <p:spPr>
            <a:xfrm>
              <a:off x="1868760" y="203688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16"/>
            <p:cNvSpPr/>
            <p:nvPr/>
          </p:nvSpPr>
          <p:spPr>
            <a:xfrm>
              <a:off x="3943080" y="323208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17"/>
            <p:cNvSpPr/>
            <p:nvPr/>
          </p:nvSpPr>
          <p:spPr>
            <a:xfrm>
              <a:off x="3625200" y="2396520"/>
              <a:ext cx="34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18"/>
            <p:cNvSpPr/>
            <p:nvPr/>
          </p:nvSpPr>
          <p:spPr>
            <a:xfrm>
              <a:off x="3937320" y="2673360"/>
              <a:ext cx="60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 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TextBox 119"/>
          <p:cNvSpPr/>
          <p:nvPr/>
        </p:nvSpPr>
        <p:spPr>
          <a:xfrm>
            <a:off x="1017360" y="15336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120"/>
          <p:cNvSpPr/>
          <p:nvPr/>
        </p:nvSpPr>
        <p:spPr>
          <a:xfrm>
            <a:off x="4844880" y="153504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121"/>
          <p:cNvSpPr/>
          <p:nvPr/>
        </p:nvSpPr>
        <p:spPr>
          <a:xfrm>
            <a:off x="4721760" y="153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165"/>
          <p:cNvSpPr/>
          <p:nvPr/>
        </p:nvSpPr>
        <p:spPr>
          <a:xfrm>
            <a:off x="5415120" y="3584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166"/>
          <p:cNvSpPr/>
          <p:nvPr/>
        </p:nvSpPr>
        <p:spPr>
          <a:xfrm>
            <a:off x="6702120" y="35845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167"/>
          <p:cNvSpPr/>
          <p:nvPr/>
        </p:nvSpPr>
        <p:spPr>
          <a:xfrm>
            <a:off x="5875560" y="3584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168"/>
          <p:cNvSpPr/>
          <p:nvPr/>
        </p:nvSpPr>
        <p:spPr>
          <a:xfrm>
            <a:off x="6339240" y="35845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169"/>
          <p:cNvSpPr/>
          <p:nvPr/>
        </p:nvSpPr>
        <p:spPr>
          <a:xfrm>
            <a:off x="5712120" y="3747960"/>
            <a:ext cx="115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rtmannin (µ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1" name="Straight Arrow Connector 73"/>
          <p:cNvCxnSpPr/>
          <p:nvPr/>
        </p:nvCxnSpPr>
        <p:spPr>
          <a:xfrm>
            <a:off x="3055680" y="3122280"/>
            <a:ext cx="91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sm" type="triangle" w="sm"/>
          </a:ln>
        </p:spPr>
      </p:cxnSp>
      <p:sp>
        <p:nvSpPr>
          <p:cNvPr id="132" name="Right Bracket 74"/>
          <p:cNvSpPr/>
          <p:nvPr/>
        </p:nvSpPr>
        <p:spPr>
          <a:xfrm>
            <a:off x="3035160" y="2676600"/>
            <a:ext cx="86040" cy="339480"/>
          </a:xfrm>
          <a:custGeom>
            <a:avLst/>
            <a:gdLst>
              <a:gd name="textAreaLeft" fmla="*/ 0 w 86040"/>
              <a:gd name="textAreaRight" fmla="*/ 60480 w 86040"/>
              <a:gd name="textAreaTop" fmla="*/ 3240 h 339480"/>
              <a:gd name="textAreaBottom" fmla="*/ 336240 h 339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27"/>
                  <a:pt x="21600" y="454"/>
                </a:cubicBezTo>
                <a:lnTo>
                  <a:pt x="21600" y="21146"/>
                </a:lnTo>
                <a:cubicBezTo>
                  <a:pt x="21600" y="21373"/>
                  <a:pt x="10800" y="21600"/>
                  <a:pt x="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71"/>
          <p:cNvGrpSpPr/>
          <p:nvPr/>
        </p:nvGrpSpPr>
        <p:grpSpPr>
          <a:xfrm>
            <a:off x="4924440" y="1890720"/>
            <a:ext cx="3000240" cy="1746360"/>
            <a:chOff x="4924440" y="1890720"/>
            <a:chExt cx="3000240" cy="1746360"/>
          </a:xfrm>
        </p:grpSpPr>
        <p:pic>
          <p:nvPicPr>
            <p:cNvPr id="134" name="Picture 2" descr=""/>
            <p:cNvPicPr/>
            <p:nvPr/>
          </p:nvPicPr>
          <p:blipFill>
            <a:blip r:embed="rId2"/>
            <a:stretch/>
          </p:blipFill>
          <p:spPr>
            <a:xfrm>
              <a:off x="4924440" y="1901160"/>
              <a:ext cx="3000240" cy="173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Rectangle 70"/>
            <p:cNvSpPr/>
            <p:nvPr/>
          </p:nvSpPr>
          <p:spPr>
            <a:xfrm>
              <a:off x="7250040" y="1890720"/>
              <a:ext cx="571320" cy="214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36" name="Picture 7" descr=""/>
          <p:cNvPicPr/>
          <p:nvPr/>
        </p:nvPicPr>
        <p:blipFill>
          <a:blip r:embed="rId3"/>
          <a:srcRect l="16624" t="-4069" r="18814" b="27127"/>
          <a:stretch/>
        </p:blipFill>
        <p:spPr>
          <a:xfrm>
            <a:off x="7230960" y="1809720"/>
            <a:ext cx="557280" cy="36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31"/>
          <p:cNvSpPr/>
          <p:nvPr/>
        </p:nvSpPr>
        <p:spPr>
          <a:xfrm>
            <a:off x="7004880" y="636732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Picture 2" descr=""/>
          <p:cNvPicPr/>
          <p:nvPr/>
        </p:nvPicPr>
        <p:blipFill>
          <a:blip r:embed="rId1"/>
          <a:stretch/>
        </p:blipFill>
        <p:spPr>
          <a:xfrm>
            <a:off x="1706400" y="871560"/>
            <a:ext cx="1683000" cy="164448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3" descr=""/>
          <p:cNvPicPr/>
          <p:nvPr/>
        </p:nvPicPr>
        <p:blipFill>
          <a:blip r:embed="rId2"/>
          <a:stretch/>
        </p:blipFill>
        <p:spPr>
          <a:xfrm>
            <a:off x="3786120" y="928800"/>
            <a:ext cx="1557360" cy="158724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4" descr=""/>
          <p:cNvPicPr/>
          <p:nvPr/>
        </p:nvPicPr>
        <p:blipFill>
          <a:blip r:embed="rId3"/>
          <a:stretch/>
        </p:blipFill>
        <p:spPr>
          <a:xfrm>
            <a:off x="5603760" y="1122480"/>
            <a:ext cx="1481400" cy="1404720"/>
          </a:xfrm>
          <a:prstGeom prst="rect">
            <a:avLst/>
          </a:prstGeom>
          <a:ln w="0">
            <a:noFill/>
          </a:ln>
        </p:spPr>
      </p:pic>
      <p:sp>
        <p:nvSpPr>
          <p:cNvPr id="141" name="TextBox 6"/>
          <p:cNvSpPr/>
          <p:nvPr/>
        </p:nvSpPr>
        <p:spPr>
          <a:xfrm>
            <a:off x="1550520" y="5475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7"/>
          <p:cNvSpPr/>
          <p:nvPr/>
        </p:nvSpPr>
        <p:spPr>
          <a:xfrm>
            <a:off x="1608840" y="26431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2" descr=""/>
          <p:cNvPicPr/>
          <p:nvPr/>
        </p:nvPicPr>
        <p:blipFill>
          <a:blip r:embed="rId4"/>
          <a:stretch/>
        </p:blipFill>
        <p:spPr>
          <a:xfrm>
            <a:off x="1609560" y="2928960"/>
            <a:ext cx="2286000" cy="1857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5T07:23:44Z</dcterms:created>
  <dc:creator>sheetal</dc:creator>
  <dc:description/>
  <dc:language>en-US</dc:language>
  <cp:lastModifiedBy>Sathees Raghavan</cp:lastModifiedBy>
  <dcterms:modified xsi:type="dcterms:W3CDTF">2014-12-24T17:21:57Z</dcterms:modified>
  <cp:revision>277</cp:revision>
  <dc:subject/>
  <dc:title>Slide 1</dc:title>
</cp:coreProperties>
</file>